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0" roundtripDataSignature="AMtx7mg6bY9iXT33sLFrok9MYgwwRNkf+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54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customschemas.google.com/relationships/presentationmetadata" Target="metadata"/><Relationship Id="rId4" Type="http://schemas.openxmlformats.org/officeDocument/2006/relationships/slide" Target="slides/slide3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82" name="Google Shape;82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g2dbcb0c19cf_1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0" name="Google Shape;100;g2dbcb0c19cf_1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28" name="Google Shape;128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Google Shape;146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47" name="Google Shape;147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Google Shape;166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67" name="Google Shape;167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6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6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4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4"/>
          <p:cNvSpPr/>
          <p:nvPr/>
        </p:nvSpPr>
        <p:spPr>
          <a:xfrm>
            <a:off x="1101774" y="368925"/>
            <a:ext cx="5051376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fr-FR" sz="1800" b="1" i="1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CA2</a:t>
            </a:r>
            <a:r>
              <a:rPr lang="fr-FR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c.2433-22889T&gt;A; </a:t>
            </a:r>
            <a:r>
              <a:rPr lang="fr-FR" sz="1800" b="1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r>
              <a:rPr lang="fr-FR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(</a:t>
            </a:r>
            <a:r>
              <a:rPr lang="fr-FR" sz="1800" b="1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rg811_Leu812ins*17)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5" name="Google Shape;85;p4"/>
          <p:cNvSpPr txBox="1"/>
          <p:nvPr/>
        </p:nvSpPr>
        <p:spPr>
          <a:xfrm>
            <a:off x="476286" y="359734"/>
            <a:ext cx="6255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0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)</a:t>
            </a:r>
            <a:endParaRPr sz="2000" b="1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3" name="Groupe 2"/>
          <p:cNvGrpSpPr/>
          <p:nvPr/>
        </p:nvGrpSpPr>
        <p:grpSpPr>
          <a:xfrm>
            <a:off x="269435" y="2087933"/>
            <a:ext cx="11340823" cy="3154498"/>
            <a:chOff x="269435" y="2087933"/>
            <a:chExt cx="11340823" cy="3154498"/>
          </a:xfrm>
        </p:grpSpPr>
        <p:grpSp>
          <p:nvGrpSpPr>
            <p:cNvPr id="86" name="Google Shape;86;p4"/>
            <p:cNvGrpSpPr/>
            <p:nvPr/>
          </p:nvGrpSpPr>
          <p:grpSpPr>
            <a:xfrm>
              <a:off x="269435" y="2087933"/>
              <a:ext cx="11340823" cy="3154498"/>
              <a:chOff x="269435" y="2147310"/>
              <a:chExt cx="11340823" cy="3154498"/>
            </a:xfrm>
          </p:grpSpPr>
          <p:grpSp>
            <p:nvGrpSpPr>
              <p:cNvPr id="87" name="Google Shape;87;p4"/>
              <p:cNvGrpSpPr/>
              <p:nvPr/>
            </p:nvGrpSpPr>
            <p:grpSpPr>
              <a:xfrm>
                <a:off x="269435" y="2587953"/>
                <a:ext cx="11340823" cy="2713855"/>
                <a:chOff x="454076" y="1803862"/>
                <a:chExt cx="11340823" cy="2713855"/>
              </a:xfrm>
            </p:grpSpPr>
            <p:pic>
              <p:nvPicPr>
                <p:cNvPr id="88" name="Google Shape;88;p4"/>
                <p:cNvPicPr preferRelativeResize="0"/>
                <p:nvPr/>
              </p:nvPicPr>
              <p:blipFill rotWithShape="1">
                <a:blip r:embed="rId3">
                  <a:alphaModFix/>
                </a:blip>
                <a:srcRect t="67297"/>
                <a:stretch/>
              </p:blipFill>
              <p:spPr>
                <a:xfrm>
                  <a:off x="454076" y="1803862"/>
                  <a:ext cx="11250595" cy="526498"/>
                </a:xfrm>
                <a:prstGeom prst="rect">
                  <a:avLst/>
                </a:prstGeom>
                <a:noFill/>
                <a:ln w="25400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</p:pic>
            <p:pic>
              <p:nvPicPr>
                <p:cNvPr id="89" name="Google Shape;89;p4"/>
                <p:cNvPicPr preferRelativeResize="0"/>
                <p:nvPr/>
              </p:nvPicPr>
              <p:blipFill rotWithShape="1">
                <a:blip r:embed="rId4">
                  <a:alphaModFix/>
                </a:blip>
                <a:srcRect t="59415" b="12784"/>
                <a:stretch/>
              </p:blipFill>
              <p:spPr>
                <a:xfrm>
                  <a:off x="563357" y="3142210"/>
                  <a:ext cx="11231542" cy="503195"/>
                </a:xfrm>
                <a:prstGeom prst="rect">
                  <a:avLst/>
                </a:prstGeom>
                <a:noFill/>
                <a:ln w="25400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</p:pic>
            <p:cxnSp>
              <p:nvCxnSpPr>
                <p:cNvPr id="90" name="Google Shape;90;p4"/>
                <p:cNvCxnSpPr>
                  <a:endCxn id="91" idx="0"/>
                </p:cNvCxnSpPr>
                <p:nvPr/>
              </p:nvCxnSpPr>
              <p:spPr>
                <a:xfrm>
                  <a:off x="7774049" y="2304887"/>
                  <a:ext cx="10800" cy="342000"/>
                </a:xfrm>
                <a:prstGeom prst="straightConnector1">
                  <a:avLst/>
                </a:prstGeom>
                <a:noFill/>
                <a:ln w="25400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</p:cxnSp>
            <p:cxnSp>
              <p:nvCxnSpPr>
                <p:cNvPr id="92" name="Google Shape;92;p4"/>
                <p:cNvCxnSpPr/>
                <p:nvPr/>
              </p:nvCxnSpPr>
              <p:spPr>
                <a:xfrm>
                  <a:off x="7883436" y="3578399"/>
                  <a:ext cx="8312" cy="590204"/>
                </a:xfrm>
                <a:prstGeom prst="straightConnector1">
                  <a:avLst/>
                </a:prstGeom>
                <a:noFill/>
                <a:ln w="25400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</p:cxnSp>
            <p:sp>
              <p:nvSpPr>
                <p:cNvPr id="91" name="Google Shape;91;p4"/>
                <p:cNvSpPr txBox="1"/>
                <p:nvPr/>
              </p:nvSpPr>
              <p:spPr>
                <a:xfrm>
                  <a:off x="7497773" y="2646887"/>
                  <a:ext cx="574151" cy="369291"/>
                </a:xfrm>
                <a:prstGeom prst="rect">
                  <a:avLst/>
                </a:prstGeom>
                <a:noFill/>
                <a:ln w="25400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800"/>
                    <a:buFont typeface="Arial"/>
                    <a:buNone/>
                  </a:pPr>
                  <a:r>
                    <a:rPr lang="fr-FR" sz="1800" b="1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812</a:t>
                  </a:r>
                  <a:endParaRPr sz="1800" b="1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  <p:sp>
              <p:nvSpPr>
                <p:cNvPr id="93" name="Google Shape;93;p4"/>
                <p:cNvSpPr txBox="1"/>
                <p:nvPr/>
              </p:nvSpPr>
              <p:spPr>
                <a:xfrm>
                  <a:off x="7631046" y="4148426"/>
                  <a:ext cx="544172" cy="369291"/>
                </a:xfrm>
                <a:prstGeom prst="rect">
                  <a:avLst/>
                </a:prstGeom>
                <a:noFill/>
                <a:ln w="25400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800"/>
                    <a:buFont typeface="Arial"/>
                    <a:buNone/>
                  </a:pPr>
                  <a:r>
                    <a:rPr lang="fr-FR" sz="1800" b="1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812</a:t>
                  </a:r>
                  <a:endParaRPr sz="1800" b="1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94" name="Google Shape;94;p4"/>
              <p:cNvSpPr txBox="1"/>
              <p:nvPr/>
            </p:nvSpPr>
            <p:spPr>
              <a:xfrm>
                <a:off x="433287" y="2147310"/>
                <a:ext cx="625363" cy="307777"/>
              </a:xfrm>
              <a:prstGeom prst="rect">
                <a:avLst/>
              </a:prstGeom>
              <a:noFill/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1400" b="1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WT</a:t>
                </a:r>
                <a:endParaRPr sz="14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95" name="Google Shape;95;p4"/>
              <p:cNvSpPr txBox="1"/>
              <p:nvPr/>
            </p:nvSpPr>
            <p:spPr>
              <a:xfrm>
                <a:off x="411939" y="3555094"/>
                <a:ext cx="625363" cy="307777"/>
              </a:xfrm>
              <a:prstGeom prst="rect">
                <a:avLst/>
              </a:prstGeom>
              <a:noFill/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1400" b="1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Var</a:t>
                </a:r>
                <a:endParaRPr sz="14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96" name="Google Shape;96;p4"/>
              <p:cNvSpPr/>
              <p:nvPr/>
            </p:nvSpPr>
            <p:spPr>
              <a:xfrm>
                <a:off x="7519173" y="2897580"/>
                <a:ext cx="152285" cy="187665"/>
              </a:xfrm>
              <a:prstGeom prst="rect">
                <a:avLst/>
              </a:prstGeom>
              <a:noFill/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4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97" name="Google Shape;97;p4"/>
              <p:cNvSpPr/>
              <p:nvPr/>
            </p:nvSpPr>
            <p:spPr>
              <a:xfrm>
                <a:off x="7620108" y="4197927"/>
                <a:ext cx="152285" cy="187665"/>
              </a:xfrm>
              <a:prstGeom prst="rect">
                <a:avLst/>
              </a:prstGeom>
              <a:noFill/>
              <a:ln w="25400" cap="flat" cmpd="sng">
                <a:solidFill>
                  <a:srgbClr val="FF0000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4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sp>
          <p:nvSpPr>
            <p:cNvPr id="2" name="Rectangle 1"/>
            <p:cNvSpPr/>
            <p:nvPr/>
          </p:nvSpPr>
          <p:spPr>
            <a:xfrm>
              <a:off x="9191502" y="4143056"/>
              <a:ext cx="2418756" cy="2116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Google Shape;102;g2dbcb0c19cf_1_0"/>
          <p:cNvSpPr txBox="1"/>
          <p:nvPr/>
        </p:nvSpPr>
        <p:spPr>
          <a:xfrm>
            <a:off x="1223725" y="390225"/>
            <a:ext cx="48129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 i="1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CA2</a:t>
            </a:r>
            <a:r>
              <a:rPr lang="fr-FR" sz="1800" b="1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fr-FR" sz="1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.2080-158A&gt;G p.(Glu693_Ala694ins41)</a:t>
            </a:r>
            <a:endParaRPr sz="18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3" name="Google Shape;103;g2dbcb0c19cf_1_0"/>
          <p:cNvSpPr txBox="1"/>
          <p:nvPr/>
        </p:nvSpPr>
        <p:spPr>
          <a:xfrm>
            <a:off x="526834" y="374777"/>
            <a:ext cx="4923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0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)</a:t>
            </a:r>
            <a:endParaRPr sz="2000" b="1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4" name="Google Shape;104;g2dbcb0c19cf_1_0"/>
          <p:cNvGrpSpPr/>
          <p:nvPr/>
        </p:nvGrpSpPr>
        <p:grpSpPr>
          <a:xfrm>
            <a:off x="730964" y="3892895"/>
            <a:ext cx="11152951" cy="1317193"/>
            <a:chOff x="360535" y="3779917"/>
            <a:chExt cx="11152951" cy="1317193"/>
          </a:xfrm>
        </p:grpSpPr>
        <p:pic>
          <p:nvPicPr>
            <p:cNvPr id="105" name="Google Shape;105;g2dbcb0c19cf_1_0"/>
            <p:cNvPicPr preferRelativeResize="0"/>
            <p:nvPr/>
          </p:nvPicPr>
          <p:blipFill rotWithShape="1">
            <a:blip r:embed="rId3">
              <a:alphaModFix/>
            </a:blip>
            <a:srcRect l="697" t="38572" r="1159" b="9703"/>
            <a:stretch/>
          </p:blipFill>
          <p:spPr>
            <a:xfrm>
              <a:off x="401739" y="4225037"/>
              <a:ext cx="10770920" cy="700645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cxnSp>
          <p:nvCxnSpPr>
            <p:cNvPr id="106" name="Google Shape;106;g2dbcb0c19cf_1_0"/>
            <p:cNvCxnSpPr/>
            <p:nvPr/>
          </p:nvCxnSpPr>
          <p:spPr>
            <a:xfrm>
              <a:off x="5533901" y="3954697"/>
              <a:ext cx="9581" cy="1130538"/>
            </a:xfrm>
            <a:prstGeom prst="straightConnector1">
              <a:avLst/>
            </a:prstGeom>
            <a:solidFill>
              <a:schemeClr val="lt1"/>
            </a:solidFill>
            <a:ln w="25400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p:spPr>
        </p:cxnSp>
        <p:sp>
          <p:nvSpPr>
            <p:cNvPr id="107" name="Google Shape;107;g2dbcb0c19cf_1_0"/>
            <p:cNvSpPr txBox="1"/>
            <p:nvPr/>
          </p:nvSpPr>
          <p:spPr>
            <a:xfrm>
              <a:off x="2482260" y="3801857"/>
              <a:ext cx="997500" cy="307800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fr-FR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Exon 19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08" name="Google Shape;108;g2dbcb0c19cf_1_0"/>
            <p:cNvSpPr txBox="1"/>
            <p:nvPr/>
          </p:nvSpPr>
          <p:spPr>
            <a:xfrm>
              <a:off x="7339267" y="3803303"/>
              <a:ext cx="997528" cy="307777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fr-FR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PE 41 AA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09" name="Google Shape;109;g2dbcb0c19cf_1_0"/>
            <p:cNvSpPr txBox="1"/>
            <p:nvPr/>
          </p:nvSpPr>
          <p:spPr>
            <a:xfrm>
              <a:off x="10677939" y="3801857"/>
              <a:ext cx="835547" cy="307736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fr-FR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Exon 20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0" name="Google Shape;110;g2dbcb0c19cf_1_0"/>
            <p:cNvSpPr txBox="1"/>
            <p:nvPr/>
          </p:nvSpPr>
          <p:spPr>
            <a:xfrm>
              <a:off x="360535" y="3779917"/>
              <a:ext cx="494174" cy="307777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4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Var</a:t>
              </a:r>
              <a:endParaRPr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11" name="Google Shape;111;g2dbcb0c19cf_1_0"/>
            <p:cNvCxnSpPr/>
            <p:nvPr/>
          </p:nvCxnSpPr>
          <p:spPr>
            <a:xfrm flipH="1">
              <a:off x="10469761" y="3981306"/>
              <a:ext cx="2295" cy="1115804"/>
            </a:xfrm>
            <a:prstGeom prst="straightConnector1">
              <a:avLst/>
            </a:prstGeom>
            <a:solidFill>
              <a:schemeClr val="lt1"/>
            </a:solidFill>
            <a:ln w="25400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grpSp>
        <p:nvGrpSpPr>
          <p:cNvPr id="112" name="Google Shape;112;g2dbcb0c19cf_1_0"/>
          <p:cNvGrpSpPr/>
          <p:nvPr/>
        </p:nvGrpSpPr>
        <p:grpSpPr>
          <a:xfrm>
            <a:off x="887997" y="1818148"/>
            <a:ext cx="9646721" cy="1157873"/>
            <a:chOff x="-455220" y="1631900"/>
            <a:chExt cx="9646721" cy="1157873"/>
          </a:xfrm>
        </p:grpSpPr>
        <p:pic>
          <p:nvPicPr>
            <p:cNvPr id="113" name="Google Shape;113;g2dbcb0c19cf_1_0"/>
            <p:cNvPicPr preferRelativeResize="0"/>
            <p:nvPr/>
          </p:nvPicPr>
          <p:blipFill rotWithShape="1">
            <a:blip r:embed="rId4">
              <a:alphaModFix/>
            </a:blip>
            <a:srcRect l="975" t="50127" r="29588" b="14696"/>
            <a:stretch/>
          </p:blipFill>
          <p:spPr>
            <a:xfrm>
              <a:off x="1587336" y="2085293"/>
              <a:ext cx="7604165" cy="384776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cxnSp>
          <p:nvCxnSpPr>
            <p:cNvPr id="114" name="Google Shape;114;g2dbcb0c19cf_1_0"/>
            <p:cNvCxnSpPr/>
            <p:nvPr/>
          </p:nvCxnSpPr>
          <p:spPr>
            <a:xfrm>
              <a:off x="6996544" y="1783163"/>
              <a:ext cx="11876" cy="1006610"/>
            </a:xfrm>
            <a:prstGeom prst="straightConnector1">
              <a:avLst/>
            </a:prstGeom>
            <a:solidFill>
              <a:schemeClr val="lt1"/>
            </a:solidFill>
            <a:ln w="25400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p:spPr>
        </p:cxnSp>
        <p:sp>
          <p:nvSpPr>
            <p:cNvPr id="115" name="Google Shape;115;g2dbcb0c19cf_1_0"/>
            <p:cNvSpPr txBox="1"/>
            <p:nvPr/>
          </p:nvSpPr>
          <p:spPr>
            <a:xfrm>
              <a:off x="3855479" y="1631900"/>
              <a:ext cx="997500" cy="307800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fr-FR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Exon 19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6" name="Google Shape;116;g2dbcb0c19cf_1_0"/>
            <p:cNvSpPr txBox="1"/>
            <p:nvPr/>
          </p:nvSpPr>
          <p:spPr>
            <a:xfrm>
              <a:off x="7673163" y="1655066"/>
              <a:ext cx="846000" cy="307800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fr-FR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Exon 20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7" name="Google Shape;117;g2dbcb0c19cf_1_0"/>
            <p:cNvSpPr txBox="1"/>
            <p:nvPr/>
          </p:nvSpPr>
          <p:spPr>
            <a:xfrm>
              <a:off x="-455220" y="1631900"/>
              <a:ext cx="608294" cy="307777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4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WT</a:t>
              </a:r>
              <a:endParaRPr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118" name="Google Shape;118;g2dbcb0c19cf_1_0"/>
          <p:cNvSpPr txBox="1"/>
          <p:nvPr/>
        </p:nvSpPr>
        <p:spPr>
          <a:xfrm>
            <a:off x="7929925" y="1531800"/>
            <a:ext cx="545100" cy="44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93</a:t>
            </a:r>
            <a:endParaRPr sz="17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9" name="Google Shape;119;g2dbcb0c19cf_1_0"/>
          <p:cNvSpPr txBox="1"/>
          <p:nvPr/>
        </p:nvSpPr>
        <p:spPr>
          <a:xfrm>
            <a:off x="8288600" y="1531800"/>
            <a:ext cx="545100" cy="44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94</a:t>
            </a:r>
            <a:endParaRPr sz="17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0" name="Google Shape;120;g2dbcb0c19cf_1_0"/>
          <p:cNvCxnSpPr/>
          <p:nvPr/>
        </p:nvCxnSpPr>
        <p:spPr>
          <a:xfrm>
            <a:off x="8288600" y="1848875"/>
            <a:ext cx="3600" cy="3426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21" name="Google Shape;121;g2dbcb0c19cf_1_0"/>
          <p:cNvCxnSpPr/>
          <p:nvPr/>
        </p:nvCxnSpPr>
        <p:spPr>
          <a:xfrm>
            <a:off x="8398825" y="1858100"/>
            <a:ext cx="3600" cy="3426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22" name="Google Shape;122;g2dbcb0c19cf_1_0"/>
          <p:cNvSpPr txBox="1"/>
          <p:nvPr/>
        </p:nvSpPr>
        <p:spPr>
          <a:xfrm>
            <a:off x="5491525" y="3589200"/>
            <a:ext cx="545100" cy="44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93</a:t>
            </a:r>
            <a:endParaRPr sz="17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3" name="Google Shape;123;g2dbcb0c19cf_1_0"/>
          <p:cNvCxnSpPr/>
          <p:nvPr/>
        </p:nvCxnSpPr>
        <p:spPr>
          <a:xfrm>
            <a:off x="5850200" y="3906275"/>
            <a:ext cx="3600" cy="3426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24" name="Google Shape;124;g2dbcb0c19cf_1_0"/>
          <p:cNvSpPr txBox="1"/>
          <p:nvPr/>
        </p:nvSpPr>
        <p:spPr>
          <a:xfrm>
            <a:off x="10803200" y="3436800"/>
            <a:ext cx="975600" cy="44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94(+41)</a:t>
            </a:r>
            <a:endParaRPr sz="17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5" name="Google Shape;125;g2dbcb0c19cf_1_0"/>
          <p:cNvCxnSpPr/>
          <p:nvPr/>
        </p:nvCxnSpPr>
        <p:spPr>
          <a:xfrm>
            <a:off x="10913425" y="3915500"/>
            <a:ext cx="3600" cy="3426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1"/>
          <p:cNvSpPr/>
          <p:nvPr/>
        </p:nvSpPr>
        <p:spPr>
          <a:xfrm>
            <a:off x="1260633" y="345688"/>
            <a:ext cx="43665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fr-FR" sz="1800" b="1" i="1">
                <a:latin typeface="Calibri"/>
                <a:ea typeface="Calibri"/>
                <a:cs typeface="Calibri"/>
                <a:sym typeface="Calibri"/>
              </a:rPr>
              <a:t>TYRP1 </a:t>
            </a:r>
            <a:r>
              <a:rPr lang="fr-FR" sz="1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.415G&gt;A; p.(Val129Glyfs23*)</a:t>
            </a:r>
            <a:endParaRPr sz="18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31" name="Google Shape;131;p1"/>
          <p:cNvGrpSpPr/>
          <p:nvPr/>
        </p:nvGrpSpPr>
        <p:grpSpPr>
          <a:xfrm>
            <a:off x="464179" y="1916725"/>
            <a:ext cx="11241069" cy="1750121"/>
            <a:chOff x="528904" y="1611163"/>
            <a:chExt cx="11241069" cy="1750121"/>
          </a:xfrm>
        </p:grpSpPr>
        <p:pic>
          <p:nvPicPr>
            <p:cNvPr id="132" name="Google Shape;132;p1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528904" y="2156022"/>
              <a:ext cx="11241069" cy="676369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sp>
          <p:nvSpPr>
            <p:cNvPr id="133" name="Google Shape;133;p1"/>
            <p:cNvSpPr txBox="1"/>
            <p:nvPr/>
          </p:nvSpPr>
          <p:spPr>
            <a:xfrm>
              <a:off x="528904" y="1611163"/>
              <a:ext cx="539560" cy="369291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fr-FR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WT </a:t>
              </a:r>
              <a:endPara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34" name="Google Shape;134;p1"/>
            <p:cNvCxnSpPr/>
            <p:nvPr/>
          </p:nvCxnSpPr>
          <p:spPr>
            <a:xfrm flipH="1">
              <a:off x="1150720" y="2525354"/>
              <a:ext cx="8312" cy="463461"/>
            </a:xfrm>
            <a:prstGeom prst="straightConnector1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sp>
          <p:nvSpPr>
            <p:cNvPr id="135" name="Google Shape;135;p1"/>
            <p:cNvSpPr txBox="1"/>
            <p:nvPr/>
          </p:nvSpPr>
          <p:spPr>
            <a:xfrm>
              <a:off x="875917" y="2991993"/>
              <a:ext cx="557915" cy="369291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fr-FR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29</a:t>
              </a:r>
              <a:endPara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36" name="Google Shape;136;p1"/>
            <p:cNvSpPr/>
            <p:nvPr/>
          </p:nvSpPr>
          <p:spPr>
            <a:xfrm>
              <a:off x="1078733" y="2365288"/>
              <a:ext cx="152285" cy="187665"/>
            </a:xfrm>
            <a:prstGeom prst="rect">
              <a:avLst/>
            </a:prstGeom>
            <a:noFill/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grpSp>
        <p:nvGrpSpPr>
          <p:cNvPr id="137" name="Google Shape;137;p1"/>
          <p:cNvGrpSpPr/>
          <p:nvPr/>
        </p:nvGrpSpPr>
        <p:grpSpPr>
          <a:xfrm>
            <a:off x="492758" y="4172615"/>
            <a:ext cx="11212490" cy="1824424"/>
            <a:chOff x="501631" y="3041360"/>
            <a:chExt cx="11212490" cy="1824424"/>
          </a:xfrm>
        </p:grpSpPr>
        <p:sp>
          <p:nvSpPr>
            <p:cNvPr id="138" name="Google Shape;138;p1"/>
            <p:cNvSpPr txBox="1"/>
            <p:nvPr/>
          </p:nvSpPr>
          <p:spPr>
            <a:xfrm>
              <a:off x="514614" y="3041360"/>
              <a:ext cx="512287" cy="369291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fr-FR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Var</a:t>
              </a:r>
              <a:endPara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39" name="Google Shape;139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501631" y="3590758"/>
              <a:ext cx="11212490" cy="533474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cxnSp>
          <p:nvCxnSpPr>
            <p:cNvPr id="140" name="Google Shape;140;p1"/>
            <p:cNvCxnSpPr/>
            <p:nvPr/>
          </p:nvCxnSpPr>
          <p:spPr>
            <a:xfrm flipH="1">
              <a:off x="1111644" y="4011077"/>
              <a:ext cx="8312" cy="463461"/>
            </a:xfrm>
            <a:prstGeom prst="straightConnector1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sp>
          <p:nvSpPr>
            <p:cNvPr id="141" name="Google Shape;141;p1"/>
            <p:cNvSpPr txBox="1"/>
            <p:nvPr/>
          </p:nvSpPr>
          <p:spPr>
            <a:xfrm>
              <a:off x="839684" y="4484445"/>
              <a:ext cx="552586" cy="381339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fr-FR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29</a:t>
              </a:r>
              <a:endPara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42" name="Google Shape;142;p1"/>
            <p:cNvSpPr/>
            <p:nvPr/>
          </p:nvSpPr>
          <p:spPr>
            <a:xfrm>
              <a:off x="1041191" y="3829794"/>
              <a:ext cx="152285" cy="187665"/>
            </a:xfrm>
            <a:prstGeom prst="rect">
              <a:avLst/>
            </a:prstGeom>
            <a:noFill/>
            <a:ln w="25400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3" name="Google Shape;143;p1"/>
            <p:cNvSpPr/>
            <p:nvPr/>
          </p:nvSpPr>
          <p:spPr>
            <a:xfrm>
              <a:off x="3165563" y="3806383"/>
              <a:ext cx="4304016" cy="234486"/>
            </a:xfrm>
            <a:prstGeom prst="roundRect">
              <a:avLst>
                <a:gd name="adj" fmla="val 16667"/>
              </a:avLst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144" name="Google Shape;144;p1"/>
          <p:cNvSpPr txBox="1"/>
          <p:nvPr/>
        </p:nvSpPr>
        <p:spPr>
          <a:xfrm>
            <a:off x="490728" y="330254"/>
            <a:ext cx="4980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0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)</a:t>
            </a:r>
            <a:endParaRPr sz="2000" b="1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Google Shape;149;p2"/>
          <p:cNvSpPr/>
          <p:nvPr/>
        </p:nvSpPr>
        <p:spPr>
          <a:xfrm>
            <a:off x="1218150" y="364425"/>
            <a:ext cx="4106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fr-FR" sz="1800" b="1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YRP1 </a:t>
            </a:r>
            <a:r>
              <a:rPr lang="fr-FR" sz="1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.913+2T&gt;G; p.(Glu237Alafs80*)</a:t>
            </a:r>
            <a:endParaRPr sz="18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50" name="Google Shape;150;p2"/>
          <p:cNvGrpSpPr/>
          <p:nvPr/>
        </p:nvGrpSpPr>
        <p:grpSpPr>
          <a:xfrm>
            <a:off x="445758" y="1887508"/>
            <a:ext cx="11279174" cy="1345003"/>
            <a:chOff x="487275" y="2382147"/>
            <a:chExt cx="11279174" cy="1345003"/>
          </a:xfrm>
        </p:grpSpPr>
        <p:pic>
          <p:nvPicPr>
            <p:cNvPr id="151" name="Google Shape;151;p2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487275" y="3203202"/>
              <a:ext cx="11279174" cy="523948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cxnSp>
          <p:nvCxnSpPr>
            <p:cNvPr id="152" name="Google Shape;152;p2"/>
            <p:cNvCxnSpPr/>
            <p:nvPr/>
          </p:nvCxnSpPr>
          <p:spPr>
            <a:xfrm>
              <a:off x="10380211" y="2673687"/>
              <a:ext cx="8312" cy="590081"/>
            </a:xfrm>
            <a:prstGeom prst="straightConnector1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sp>
          <p:nvSpPr>
            <p:cNvPr id="153" name="Google Shape;153;p2"/>
            <p:cNvSpPr txBox="1"/>
            <p:nvPr/>
          </p:nvSpPr>
          <p:spPr>
            <a:xfrm>
              <a:off x="10090061" y="2382147"/>
              <a:ext cx="600982" cy="369291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fr-FR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37</a:t>
              </a:r>
              <a:endPara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54" name="Google Shape;154;p2"/>
            <p:cNvSpPr txBox="1"/>
            <p:nvPr/>
          </p:nvSpPr>
          <p:spPr>
            <a:xfrm>
              <a:off x="487275" y="2712114"/>
              <a:ext cx="615932" cy="369291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fr-FR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WT</a:t>
              </a:r>
              <a:endPara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55" name="Google Shape;155;p2"/>
            <p:cNvSpPr/>
            <p:nvPr/>
          </p:nvSpPr>
          <p:spPr>
            <a:xfrm>
              <a:off x="10317785" y="3249870"/>
              <a:ext cx="152285" cy="187665"/>
            </a:xfrm>
            <a:prstGeom prst="rect">
              <a:avLst/>
            </a:prstGeom>
            <a:noFill/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156" name="Google Shape;156;p2"/>
          <p:cNvSpPr txBox="1"/>
          <p:nvPr/>
        </p:nvSpPr>
        <p:spPr>
          <a:xfrm>
            <a:off x="481940" y="348980"/>
            <a:ext cx="7362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0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D)</a:t>
            </a:r>
            <a:endParaRPr sz="2000" b="1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57" name="Google Shape;157;p2"/>
          <p:cNvGrpSpPr/>
          <p:nvPr/>
        </p:nvGrpSpPr>
        <p:grpSpPr>
          <a:xfrm>
            <a:off x="445789" y="3825491"/>
            <a:ext cx="11279143" cy="1348725"/>
            <a:chOff x="424097" y="4524933"/>
            <a:chExt cx="11279143" cy="1348725"/>
          </a:xfrm>
        </p:grpSpPr>
        <p:grpSp>
          <p:nvGrpSpPr>
            <p:cNvPr id="158" name="Google Shape;158;p2"/>
            <p:cNvGrpSpPr/>
            <p:nvPr/>
          </p:nvGrpSpPr>
          <p:grpSpPr>
            <a:xfrm>
              <a:off x="424097" y="4524933"/>
              <a:ext cx="11279143" cy="1348725"/>
              <a:chOff x="366167" y="3969681"/>
              <a:chExt cx="11279143" cy="1348725"/>
            </a:xfrm>
          </p:grpSpPr>
          <p:pic>
            <p:nvPicPr>
              <p:cNvPr id="159" name="Google Shape;159;p2"/>
              <p:cNvPicPr preferRelativeResize="0"/>
              <p:nvPr/>
            </p:nvPicPr>
            <p:blipFill rotWithShape="1">
              <a:blip r:embed="rId4">
                <a:alphaModFix/>
              </a:blip>
              <a:srcRect/>
              <a:stretch/>
            </p:blipFill>
            <p:spPr>
              <a:xfrm>
                <a:off x="375662" y="4851616"/>
                <a:ext cx="11269648" cy="466790"/>
              </a:xfrm>
              <a:prstGeom prst="rect">
                <a:avLst/>
              </a:prstGeom>
              <a:solidFill>
                <a:schemeClr val="lt1"/>
              </a:solidFill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cxnSp>
            <p:nvCxnSpPr>
              <p:cNvPr id="160" name="Google Shape;160;p2"/>
              <p:cNvCxnSpPr/>
              <p:nvPr/>
            </p:nvCxnSpPr>
            <p:spPr>
              <a:xfrm>
                <a:off x="10238894" y="4305356"/>
                <a:ext cx="16626" cy="534385"/>
              </a:xfrm>
              <a:prstGeom prst="straightConnector1">
                <a:avLst/>
              </a:prstGeom>
              <a:solidFill>
                <a:schemeClr val="lt1"/>
              </a:solidFill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cxnSp>
          <p:sp>
            <p:nvSpPr>
              <p:cNvPr id="161" name="Google Shape;161;p2"/>
              <p:cNvSpPr txBox="1"/>
              <p:nvPr/>
            </p:nvSpPr>
            <p:spPr>
              <a:xfrm>
                <a:off x="9953996" y="3969681"/>
                <a:ext cx="592449" cy="369291"/>
              </a:xfrm>
              <a:prstGeom prst="rect">
                <a:avLst/>
              </a:prstGeom>
              <a:solidFill>
                <a:schemeClr val="lt1"/>
              </a:solidFill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r>
                  <a:rPr lang="fr-FR" sz="1800" b="1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237</a:t>
                </a:r>
                <a:endParaRPr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62" name="Google Shape;162;p2"/>
              <p:cNvSpPr txBox="1"/>
              <p:nvPr/>
            </p:nvSpPr>
            <p:spPr>
              <a:xfrm>
                <a:off x="366167" y="4305356"/>
                <a:ext cx="570790" cy="369291"/>
              </a:xfrm>
              <a:prstGeom prst="rect">
                <a:avLst/>
              </a:prstGeom>
              <a:solidFill>
                <a:schemeClr val="lt1"/>
              </a:solidFill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r>
                  <a:rPr lang="fr-FR" sz="1800" b="1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Var</a:t>
                </a:r>
                <a:endParaRPr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63" name="Google Shape;163;p2"/>
              <p:cNvSpPr/>
              <p:nvPr/>
            </p:nvSpPr>
            <p:spPr>
              <a:xfrm>
                <a:off x="10200767" y="4839741"/>
                <a:ext cx="152285" cy="187665"/>
              </a:xfrm>
              <a:prstGeom prst="rect">
                <a:avLst/>
              </a:prstGeom>
              <a:noFill/>
              <a:ln w="25400" cap="flat" cmpd="sng">
                <a:solidFill>
                  <a:srgbClr val="FF0000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4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sp>
          <p:nvSpPr>
            <p:cNvPr id="164" name="Google Shape;164;p2"/>
            <p:cNvSpPr/>
            <p:nvPr/>
          </p:nvSpPr>
          <p:spPr>
            <a:xfrm>
              <a:off x="6427189" y="5613941"/>
              <a:ext cx="3453081" cy="233395"/>
            </a:xfrm>
            <a:prstGeom prst="roundRect">
              <a:avLst>
                <a:gd name="adj" fmla="val 16667"/>
              </a:avLst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p3"/>
          <p:cNvSpPr txBox="1"/>
          <p:nvPr/>
        </p:nvSpPr>
        <p:spPr>
          <a:xfrm>
            <a:off x="1033454" y="362065"/>
            <a:ext cx="40185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 i="1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PS1</a:t>
            </a:r>
            <a:r>
              <a:rPr lang="fr-FR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c.1599-16T&gt;G; p.Ala170Profs75*</a:t>
            </a:r>
            <a:endParaRPr sz="18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70" name="Google Shape;170;p3"/>
          <p:cNvGrpSpPr/>
          <p:nvPr/>
        </p:nvGrpSpPr>
        <p:grpSpPr>
          <a:xfrm>
            <a:off x="450234" y="1906671"/>
            <a:ext cx="11517332" cy="1430295"/>
            <a:chOff x="418086" y="1975367"/>
            <a:chExt cx="11517332" cy="1430295"/>
          </a:xfrm>
        </p:grpSpPr>
        <p:sp>
          <p:nvSpPr>
            <p:cNvPr id="171" name="Google Shape;171;p3"/>
            <p:cNvSpPr txBox="1"/>
            <p:nvPr/>
          </p:nvSpPr>
          <p:spPr>
            <a:xfrm>
              <a:off x="7962593" y="1975367"/>
              <a:ext cx="540140" cy="369291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fr-FR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70</a:t>
              </a:r>
              <a:endPara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72" name="Google Shape;172;p3"/>
            <p:cNvPicPr preferRelativeResize="0"/>
            <p:nvPr/>
          </p:nvPicPr>
          <p:blipFill rotWithShape="1">
            <a:blip r:embed="rId3">
              <a:alphaModFix/>
            </a:blip>
            <a:srcRect t="10759" b="10609"/>
            <a:stretch/>
          </p:blipFill>
          <p:spPr>
            <a:xfrm>
              <a:off x="418086" y="2873828"/>
              <a:ext cx="11517332" cy="531834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cxnSp>
          <p:nvCxnSpPr>
            <p:cNvPr id="173" name="Google Shape;173;p3"/>
            <p:cNvCxnSpPr/>
            <p:nvPr/>
          </p:nvCxnSpPr>
          <p:spPr>
            <a:xfrm>
              <a:off x="8254935" y="2333825"/>
              <a:ext cx="8312" cy="590204"/>
            </a:xfrm>
            <a:prstGeom prst="straightConnector1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sp>
          <p:nvSpPr>
            <p:cNvPr id="174" name="Google Shape;174;p3"/>
            <p:cNvSpPr txBox="1"/>
            <p:nvPr/>
          </p:nvSpPr>
          <p:spPr>
            <a:xfrm>
              <a:off x="458978" y="2289316"/>
              <a:ext cx="597926" cy="369291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fr-FR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WT</a:t>
              </a:r>
              <a:endPara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75" name="Google Shape;175;p3"/>
            <p:cNvSpPr/>
            <p:nvPr/>
          </p:nvSpPr>
          <p:spPr>
            <a:xfrm>
              <a:off x="8180224" y="2917374"/>
              <a:ext cx="152285" cy="187665"/>
            </a:xfrm>
            <a:prstGeom prst="rect">
              <a:avLst/>
            </a:prstGeom>
            <a:noFill/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176" name="Google Shape;176;p3"/>
          <p:cNvSpPr txBox="1"/>
          <p:nvPr/>
        </p:nvSpPr>
        <p:spPr>
          <a:xfrm>
            <a:off x="441366" y="346618"/>
            <a:ext cx="4632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0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)</a:t>
            </a:r>
            <a:endParaRPr sz="2000" b="1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77" name="Google Shape;177;p3"/>
          <p:cNvGrpSpPr/>
          <p:nvPr/>
        </p:nvGrpSpPr>
        <p:grpSpPr>
          <a:xfrm>
            <a:off x="450234" y="4138165"/>
            <a:ext cx="11317279" cy="1446595"/>
            <a:chOff x="450234" y="3961633"/>
            <a:chExt cx="11317279" cy="1446595"/>
          </a:xfrm>
        </p:grpSpPr>
        <p:grpSp>
          <p:nvGrpSpPr>
            <p:cNvPr id="178" name="Google Shape;178;p3"/>
            <p:cNvGrpSpPr/>
            <p:nvPr/>
          </p:nvGrpSpPr>
          <p:grpSpPr>
            <a:xfrm>
              <a:off x="450234" y="3961633"/>
              <a:ext cx="11317279" cy="1446595"/>
              <a:chOff x="418086" y="3639677"/>
              <a:chExt cx="11317279" cy="1446595"/>
            </a:xfrm>
          </p:grpSpPr>
          <p:pic>
            <p:nvPicPr>
              <p:cNvPr id="179" name="Google Shape;179;p3"/>
              <p:cNvPicPr preferRelativeResize="0"/>
              <p:nvPr/>
            </p:nvPicPr>
            <p:blipFill rotWithShape="1">
              <a:blip r:embed="rId4">
                <a:alphaModFix/>
              </a:blip>
              <a:srcRect/>
              <a:stretch/>
            </p:blipFill>
            <p:spPr>
              <a:xfrm>
                <a:off x="418086" y="4600429"/>
                <a:ext cx="11317279" cy="485843"/>
              </a:xfrm>
              <a:prstGeom prst="rect">
                <a:avLst/>
              </a:prstGeom>
              <a:solidFill>
                <a:schemeClr val="lt1"/>
              </a:solidFill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cxnSp>
            <p:nvCxnSpPr>
              <p:cNvPr id="180" name="Google Shape;180;p3"/>
              <p:cNvCxnSpPr/>
              <p:nvPr/>
            </p:nvCxnSpPr>
            <p:spPr>
              <a:xfrm>
                <a:off x="8177350" y="4010225"/>
                <a:ext cx="8312" cy="590204"/>
              </a:xfrm>
              <a:prstGeom prst="straightConnector1">
                <a:avLst/>
              </a:prstGeom>
              <a:solidFill>
                <a:schemeClr val="lt1"/>
              </a:solidFill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cxnSp>
          <p:sp>
            <p:nvSpPr>
              <p:cNvPr id="181" name="Google Shape;181;p3"/>
              <p:cNvSpPr txBox="1"/>
              <p:nvPr/>
            </p:nvSpPr>
            <p:spPr>
              <a:xfrm>
                <a:off x="7893330" y="3639677"/>
                <a:ext cx="609403" cy="369291"/>
              </a:xfrm>
              <a:prstGeom prst="rect">
                <a:avLst/>
              </a:prstGeom>
              <a:solidFill>
                <a:schemeClr val="lt1"/>
              </a:solidFill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r>
                  <a:rPr lang="fr-FR" sz="1800" b="1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170</a:t>
                </a:r>
                <a:endParaRPr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82" name="Google Shape;182;p3"/>
              <p:cNvSpPr txBox="1"/>
              <p:nvPr/>
            </p:nvSpPr>
            <p:spPr>
              <a:xfrm>
                <a:off x="461252" y="4008968"/>
                <a:ext cx="597926" cy="369291"/>
              </a:xfrm>
              <a:prstGeom prst="rect">
                <a:avLst/>
              </a:prstGeom>
              <a:solidFill>
                <a:schemeClr val="lt1"/>
              </a:solidFill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r>
                  <a:rPr lang="fr-FR" sz="1800" b="1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Var </a:t>
                </a:r>
                <a:endParaRPr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83" name="Google Shape;183;p3"/>
              <p:cNvSpPr/>
              <p:nvPr/>
            </p:nvSpPr>
            <p:spPr>
              <a:xfrm>
                <a:off x="8118873" y="4601686"/>
                <a:ext cx="152285" cy="187665"/>
              </a:xfrm>
              <a:prstGeom prst="rect">
                <a:avLst/>
              </a:prstGeom>
              <a:noFill/>
              <a:ln w="25400" cap="flat" cmpd="sng">
                <a:solidFill>
                  <a:srgbClr val="FF0000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400" b="0" i="0" u="none" strike="noStrike" cap="none">
                  <a:solidFill>
                    <a:srgbClr val="FF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sp>
          <p:nvSpPr>
            <p:cNvPr id="184" name="Google Shape;184;p3"/>
            <p:cNvSpPr/>
            <p:nvPr/>
          </p:nvSpPr>
          <p:spPr>
            <a:xfrm>
              <a:off x="3869836" y="5111307"/>
              <a:ext cx="1842194" cy="236485"/>
            </a:xfrm>
            <a:prstGeom prst="roundRect">
              <a:avLst>
                <a:gd name="adj" fmla="val 0"/>
              </a:avLst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8</Words>
  <Application>Microsoft Office PowerPoint</Application>
  <PresentationFormat>Grand écran</PresentationFormat>
  <Paragraphs>37</Paragraphs>
  <Slides>5</Slides>
  <Notes>5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8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lateau Technique Biologie Moléculaire - Pellegrin</dc:creator>
  <cp:lastModifiedBy>ARVEILER Benoit</cp:lastModifiedBy>
  <cp:revision>4</cp:revision>
  <dcterms:created xsi:type="dcterms:W3CDTF">2024-04-24T09:04:36Z</dcterms:created>
  <dcterms:modified xsi:type="dcterms:W3CDTF">2024-07-26T14:34:08Z</dcterms:modified>
</cp:coreProperties>
</file>